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92" d="100"/>
          <a:sy n="92" d="100"/>
        </p:scale>
        <p:origin x="49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B8B9E-D9D3-4169-B64F-CB8ABE1441C0}" type="datetimeFigureOut">
              <a:rPr lang="en-ZA" smtClean="0"/>
              <a:t>2019/03/22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3E35B1-7E6A-4D25-AE13-EBF4BFF60847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6574972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B8B9E-D9D3-4169-B64F-CB8ABE1441C0}" type="datetimeFigureOut">
              <a:rPr lang="en-ZA" smtClean="0"/>
              <a:t>2019/03/22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3E35B1-7E6A-4D25-AE13-EBF4BFF60847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990905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B8B9E-D9D3-4169-B64F-CB8ABE1441C0}" type="datetimeFigureOut">
              <a:rPr lang="en-ZA" smtClean="0"/>
              <a:t>2019/03/22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3E35B1-7E6A-4D25-AE13-EBF4BFF60847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5292692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B8B9E-D9D3-4169-B64F-CB8ABE1441C0}" type="datetimeFigureOut">
              <a:rPr lang="en-ZA" smtClean="0"/>
              <a:t>2019/03/22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3E35B1-7E6A-4D25-AE13-EBF4BFF60847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1053196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B8B9E-D9D3-4169-B64F-CB8ABE1441C0}" type="datetimeFigureOut">
              <a:rPr lang="en-ZA" smtClean="0"/>
              <a:t>2019/03/22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3E35B1-7E6A-4D25-AE13-EBF4BFF60847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3571757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B8B9E-D9D3-4169-B64F-CB8ABE1441C0}" type="datetimeFigureOut">
              <a:rPr lang="en-ZA" smtClean="0"/>
              <a:t>2019/03/22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3E35B1-7E6A-4D25-AE13-EBF4BFF60847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3548628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B8B9E-D9D3-4169-B64F-CB8ABE1441C0}" type="datetimeFigureOut">
              <a:rPr lang="en-ZA" smtClean="0"/>
              <a:t>2019/03/22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3E35B1-7E6A-4D25-AE13-EBF4BFF60847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9120921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B8B9E-D9D3-4169-B64F-CB8ABE1441C0}" type="datetimeFigureOut">
              <a:rPr lang="en-ZA" smtClean="0"/>
              <a:t>2019/03/22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3E35B1-7E6A-4D25-AE13-EBF4BFF60847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3207013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B8B9E-D9D3-4169-B64F-CB8ABE1441C0}" type="datetimeFigureOut">
              <a:rPr lang="en-ZA" smtClean="0"/>
              <a:t>2019/03/22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3E35B1-7E6A-4D25-AE13-EBF4BFF60847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4057154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B8B9E-D9D3-4169-B64F-CB8ABE1441C0}" type="datetimeFigureOut">
              <a:rPr lang="en-ZA" smtClean="0"/>
              <a:t>2019/03/22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3E35B1-7E6A-4D25-AE13-EBF4BFF60847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0708741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6B8B9E-D9D3-4169-B64F-CB8ABE1441C0}" type="datetimeFigureOut">
              <a:rPr lang="en-ZA" smtClean="0"/>
              <a:t>2019/03/22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3E35B1-7E6A-4D25-AE13-EBF4BFF60847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5152417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6B8B9E-D9D3-4169-B64F-CB8ABE1441C0}" type="datetimeFigureOut">
              <a:rPr lang="en-ZA" smtClean="0"/>
              <a:t>2019/03/22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3E35B1-7E6A-4D25-AE13-EBF4BFF60847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4110514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79306345"/>
              </p:ext>
            </p:extLst>
          </p:nvPr>
        </p:nvGraphicFramePr>
        <p:xfrm>
          <a:off x="857249" y="672811"/>
          <a:ext cx="6215069" cy="4704666"/>
        </p:xfrm>
        <a:graphic>
          <a:graphicData uri="http://schemas.openxmlformats.org/drawingml/2006/table">
            <a:tbl>
              <a:tblPr/>
              <a:tblGrid>
                <a:gridCol w="985839">
                  <a:extLst>
                    <a:ext uri="{9D8B030D-6E8A-4147-A177-3AD203B41FA5}">
                      <a16:colId xmlns="" xmlns:a16="http://schemas.microsoft.com/office/drawing/2014/main" val="2767121789"/>
                    </a:ext>
                  </a:extLst>
                </a:gridCol>
                <a:gridCol w="1628775">
                  <a:extLst>
                    <a:ext uri="{9D8B030D-6E8A-4147-A177-3AD203B41FA5}">
                      <a16:colId xmlns="" xmlns:a16="http://schemas.microsoft.com/office/drawing/2014/main" val="3963394710"/>
                    </a:ext>
                  </a:extLst>
                </a:gridCol>
                <a:gridCol w="114300">
                  <a:extLst>
                    <a:ext uri="{9D8B030D-6E8A-4147-A177-3AD203B41FA5}">
                      <a16:colId xmlns="" xmlns:a16="http://schemas.microsoft.com/office/drawing/2014/main" val="2682656229"/>
                    </a:ext>
                  </a:extLst>
                </a:gridCol>
                <a:gridCol w="1685925">
                  <a:extLst>
                    <a:ext uri="{9D8B030D-6E8A-4147-A177-3AD203B41FA5}">
                      <a16:colId xmlns="" xmlns:a16="http://schemas.microsoft.com/office/drawing/2014/main" val="3330420698"/>
                    </a:ext>
                  </a:extLst>
                </a:gridCol>
                <a:gridCol w="328511">
                  <a:extLst>
                    <a:ext uri="{9D8B030D-6E8A-4147-A177-3AD203B41FA5}">
                      <a16:colId xmlns="" xmlns:a16="http://schemas.microsoft.com/office/drawing/2014/main" val="1264055680"/>
                    </a:ext>
                  </a:extLst>
                </a:gridCol>
                <a:gridCol w="1471719">
                  <a:extLst>
                    <a:ext uri="{9D8B030D-6E8A-4147-A177-3AD203B41FA5}">
                      <a16:colId xmlns="" xmlns:a16="http://schemas.microsoft.com/office/drawing/2014/main" val="387104127"/>
                    </a:ext>
                  </a:extLst>
                </a:gridCol>
              </a:tblGrid>
              <a:tr h="228828"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endParaRPr lang="en-US" dirty="0"/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868578537"/>
                  </a:ext>
                </a:extLst>
              </a:tr>
              <a:tr h="228828"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5">
                  <a:txBody>
                    <a:bodyPr/>
                    <a:lstStyle/>
                    <a:p>
                      <a:pPr algn="ctr" fontAlgn="b"/>
                      <a:r>
                        <a:rPr lang="en-ZA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edian viral load change (IQR</a:t>
                      </a:r>
                      <a:r>
                        <a:rPr lang="en-ZA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*</a:t>
                      </a:r>
                      <a:endParaRPr lang="en-ZA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2607343374"/>
                  </a:ext>
                </a:extLst>
              </a:tr>
              <a:tr h="228828">
                <a:tc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DT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P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l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623841923"/>
                  </a:ext>
                </a:extLst>
              </a:tr>
              <a:tr h="4361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⁰C 72hr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16 (-0.34 - 0.05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6 (-0.25 – 0.08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13 (-0.27 – 0.07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3480929474"/>
                  </a:ext>
                </a:extLst>
              </a:tr>
              <a:tr h="43873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⁰C 96hr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8 (-0.29 - 0.05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4 (-0.16 – 0.09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6 (-0.17 – 0.09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597024129"/>
                  </a:ext>
                </a:extLst>
              </a:tr>
              <a:tr h="43417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⁰C 168hr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24 (-0.36 - 0.05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13 (-0.32 – 0.04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16 (0.34 – 0)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2474118649"/>
                  </a:ext>
                </a:extLst>
              </a:tr>
              <a:tr h="43417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⁰C 72hr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7 (-0.04 - 0.45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4D6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 (-0.04 – 0.22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4D6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2 (-0.04 – 0.26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4D6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3105026530"/>
                  </a:ext>
                </a:extLst>
              </a:tr>
              <a:tr h="43417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⁰C 96hr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8 (-0.20 - 0.07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8 (-0.21 – 0.11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8 (-0.2 – 0.09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2876563521"/>
                  </a:ext>
                </a:extLst>
              </a:tr>
              <a:tr h="43417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⁰C 168hr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05 (-0.16 – 0.04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E1F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6 (-0.11 – 0.21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4D6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(-0.15 – 0.15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294463233"/>
                  </a:ext>
                </a:extLst>
              </a:tr>
              <a:tr h="43417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⁰C 72hr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 (-0.04 – 0.22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4D6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2 (-0.04 – 0.32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4D6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 (-0.04 – 0.27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4D6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2211827795"/>
                  </a:ext>
                </a:extLst>
              </a:tr>
              <a:tr h="43417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⁰C 96hr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 (-0.23 – 0.20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 (-0.05 – 0.01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 (-0.11 – 0.11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93407120"/>
                  </a:ext>
                </a:extLst>
              </a:tr>
              <a:tr h="43417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⁰C 168hr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7 (-0.04 – 0.48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4D6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5 (0 – 0.28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4D6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6 (-0.02 – 0.34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4D6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CE4D6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352234992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71475" y="391209"/>
            <a:ext cx="6917022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sz="1600" b="1" dirty="0" smtClean="0"/>
              <a:t>S1 Table Median </a:t>
            </a:r>
            <a:r>
              <a:rPr lang="en-ZA" sz="1600" b="1" dirty="0"/>
              <a:t>log viral load change between test 1 and test 2 according to </a:t>
            </a:r>
            <a:endParaRPr lang="en-ZA" sz="1600" b="1" dirty="0" smtClean="0"/>
          </a:p>
          <a:p>
            <a:r>
              <a:rPr lang="en-ZA" sz="1600" b="1" dirty="0" smtClean="0"/>
              <a:t>storage </a:t>
            </a:r>
            <a:r>
              <a:rPr lang="en-ZA" sz="1600" b="1" dirty="0"/>
              <a:t>category</a:t>
            </a:r>
            <a:endParaRPr lang="en-US" sz="1600" dirty="0"/>
          </a:p>
          <a:p>
            <a:endParaRPr lang="en-US" sz="1600" dirty="0"/>
          </a:p>
        </p:txBody>
      </p:sp>
      <p:sp>
        <p:nvSpPr>
          <p:cNvPr id="6" name="TextBox 5"/>
          <p:cNvSpPr txBox="1"/>
          <p:nvPr/>
        </p:nvSpPr>
        <p:spPr>
          <a:xfrm>
            <a:off x="371475" y="5377477"/>
            <a:ext cx="6842899" cy="16004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/>
              <a:t>*Samples with undetectable viral load in test 1 excluded</a:t>
            </a:r>
            <a:endParaRPr lang="en-US" dirty="0"/>
          </a:p>
          <a:p>
            <a:endParaRPr lang="en-ZA" sz="800" dirty="0" smtClean="0"/>
          </a:p>
          <a:p>
            <a:r>
              <a:rPr lang="en-ZA" dirty="0" smtClean="0"/>
              <a:t>Blue </a:t>
            </a:r>
            <a:r>
              <a:rPr lang="en-ZA" dirty="0"/>
              <a:t>shading indicates categories with median viral load decay.  Pink </a:t>
            </a:r>
            <a:endParaRPr lang="en-ZA" dirty="0" smtClean="0"/>
          </a:p>
          <a:p>
            <a:r>
              <a:rPr lang="en-ZA" dirty="0" smtClean="0"/>
              <a:t>shading </a:t>
            </a:r>
            <a:r>
              <a:rPr lang="en-ZA" dirty="0"/>
              <a:t>indicates categories with increased </a:t>
            </a:r>
            <a:r>
              <a:rPr lang="en-ZA" dirty="0" smtClean="0"/>
              <a:t>median</a:t>
            </a:r>
          </a:p>
          <a:p>
            <a:r>
              <a:rPr lang="en-ZA" dirty="0" smtClean="0"/>
              <a:t>viral </a:t>
            </a:r>
            <a:r>
              <a:rPr lang="en-ZA" dirty="0"/>
              <a:t>load. No fill indicates </a:t>
            </a:r>
            <a:r>
              <a:rPr lang="en-ZA" dirty="0" smtClean="0"/>
              <a:t>change </a:t>
            </a:r>
            <a:r>
              <a:rPr lang="en-ZA" dirty="0"/>
              <a:t>in viral </a:t>
            </a:r>
            <a:r>
              <a:rPr lang="en-ZA" dirty="0" smtClean="0"/>
              <a:t>load &lt;0.05 log copies per ml.  </a:t>
            </a: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914412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2</Words>
  <Application>Microsoft Office PowerPoint</Application>
  <PresentationFormat>Widescreen</PresentationFormat>
  <Paragraphs>4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Cape Town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Windows User</cp:lastModifiedBy>
  <cp:revision>1</cp:revision>
  <dcterms:created xsi:type="dcterms:W3CDTF">2019-03-22T09:12:24Z</dcterms:created>
  <dcterms:modified xsi:type="dcterms:W3CDTF">2019-03-22T09:12:47Z</dcterms:modified>
</cp:coreProperties>
</file>